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62" d="100"/>
          <a:sy n="62" d="100"/>
        </p:scale>
        <p:origin x="-1744" y="-12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b-NO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AB5869-3BF0-EF43-B96A-1EE3F9971708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B5834-6ACB-814B-BDB7-592061A2C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58592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AB5869-3BF0-EF43-B96A-1EE3F9971708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B5834-6ACB-814B-BDB7-592061A2C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39577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AB5869-3BF0-EF43-B96A-1EE3F9971708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B5834-6ACB-814B-BDB7-592061A2C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67672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AB5869-3BF0-EF43-B96A-1EE3F9971708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B5834-6ACB-814B-BDB7-592061A2C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44696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AB5869-3BF0-EF43-B96A-1EE3F9971708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B5834-6ACB-814B-BDB7-592061A2C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16330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AB5869-3BF0-EF43-B96A-1EE3F9971708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B5834-6ACB-814B-BDB7-592061A2C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78483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AB5869-3BF0-EF43-B96A-1EE3F9971708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B5834-6ACB-814B-BDB7-592061A2C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48322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AB5869-3BF0-EF43-B96A-1EE3F9971708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B5834-6ACB-814B-BDB7-592061A2C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90934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AB5869-3BF0-EF43-B96A-1EE3F9971708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B5834-6ACB-814B-BDB7-592061A2C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86955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AB5869-3BF0-EF43-B96A-1EE3F9971708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B5834-6ACB-814B-BDB7-592061A2C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81933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AB5869-3BF0-EF43-B96A-1EE3F9971708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B5834-6ACB-814B-BDB7-592061A2C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18356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AB5869-3BF0-EF43-B96A-1EE3F9971708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8B5834-6ACB-814B-BDB7-592061A2C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18813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" y="18403"/>
            <a:ext cx="11633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/>
                <a:cs typeface="Times New Roman"/>
              </a:rPr>
              <a:t>S7 Figure</a:t>
            </a:r>
            <a:endParaRPr lang="en-US" sz="1600" b="1" dirty="0">
              <a:latin typeface="Times New Roman"/>
              <a:cs typeface="Times New Roman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1" y="4429109"/>
            <a:ext cx="9144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/>
                <a:cs typeface="Times New Roman"/>
              </a:rPr>
              <a:t>S7 Fig. </a:t>
            </a:r>
            <a:r>
              <a:rPr lang="en-US" sz="1200" b="1" dirty="0">
                <a:latin typeface="Times New Roman"/>
                <a:cs typeface="Times New Roman"/>
              </a:rPr>
              <a:t>Expression of GR mRNA in </a:t>
            </a:r>
            <a:r>
              <a:rPr lang="en-US" sz="1200" b="1" dirty="0" err="1">
                <a:latin typeface="Times New Roman"/>
                <a:cs typeface="Times New Roman"/>
              </a:rPr>
              <a:t>wt</a:t>
            </a:r>
            <a:r>
              <a:rPr lang="en-US" sz="1200" b="1" dirty="0">
                <a:latin typeface="Times New Roman"/>
                <a:cs typeface="Times New Roman"/>
              </a:rPr>
              <a:t>, Epac1</a:t>
            </a:r>
            <a:r>
              <a:rPr lang="en-US" sz="1200" b="1" baseline="30000" dirty="0">
                <a:latin typeface="Times New Roman"/>
                <a:cs typeface="Times New Roman"/>
              </a:rPr>
              <a:t>-/-</a:t>
            </a:r>
            <a:r>
              <a:rPr lang="en-US" sz="1200" b="1" dirty="0">
                <a:latin typeface="Times New Roman"/>
                <a:cs typeface="Times New Roman"/>
              </a:rPr>
              <a:t>, Epac2</a:t>
            </a:r>
            <a:r>
              <a:rPr lang="en-US" sz="1200" b="1" baseline="30000" dirty="0">
                <a:latin typeface="Times New Roman"/>
                <a:cs typeface="Times New Roman"/>
              </a:rPr>
              <a:t>-/- </a:t>
            </a:r>
            <a:r>
              <a:rPr lang="en-US" sz="1200" b="1" dirty="0">
                <a:latin typeface="Times New Roman"/>
                <a:cs typeface="Times New Roman"/>
              </a:rPr>
              <a:t>and Epac1/2</a:t>
            </a:r>
            <a:r>
              <a:rPr lang="en-US" sz="1200" b="1" baseline="30000" dirty="0">
                <a:latin typeface="Times New Roman"/>
                <a:cs typeface="Times New Roman"/>
              </a:rPr>
              <a:t>-/- </a:t>
            </a:r>
            <a:r>
              <a:rPr lang="en-US" sz="1200" b="1" dirty="0">
                <a:latin typeface="Times New Roman"/>
                <a:cs typeface="Times New Roman"/>
              </a:rPr>
              <a:t>mice following restraint </a:t>
            </a:r>
            <a:r>
              <a:rPr lang="en-US" sz="1200" b="1" dirty="0" smtClean="0">
                <a:latin typeface="Times New Roman"/>
                <a:cs typeface="Times New Roman"/>
              </a:rPr>
              <a:t>stress.</a:t>
            </a:r>
            <a:r>
              <a:rPr lang="en-US" sz="1200" dirty="0" smtClean="0">
                <a:latin typeface="Times New Roman"/>
                <a:cs typeface="Times New Roman"/>
              </a:rPr>
              <a:t> </a:t>
            </a:r>
            <a:r>
              <a:rPr lang="x-none" sz="1200" dirty="0">
                <a:latin typeface="Times New Roman"/>
                <a:cs typeface="Times New Roman"/>
              </a:rPr>
              <a:t> </a:t>
            </a:r>
            <a:endParaRPr lang="en-US" sz="1200" dirty="0">
              <a:latin typeface="Times New Roman"/>
              <a:cs typeface="Times New Roman"/>
            </a:endParaRPr>
          </a:p>
        </p:txBody>
      </p:sp>
      <p:pic>
        <p:nvPicPr>
          <p:cNvPr id="5" name="Picture 4" descr="1 - 9 paralleller KSÅ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78301"/>
            <a:ext cx="9144000" cy="31610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340120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3</Words>
  <Application>Microsoft Macintosh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iB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hrine Sivertsen Åsrud</dc:creator>
  <cp:lastModifiedBy>Kathrine Sivertsen Åsrud</cp:lastModifiedBy>
  <cp:revision>1</cp:revision>
  <dcterms:created xsi:type="dcterms:W3CDTF">2018-03-05T13:32:11Z</dcterms:created>
  <dcterms:modified xsi:type="dcterms:W3CDTF">2018-03-05T13:32:35Z</dcterms:modified>
</cp:coreProperties>
</file>